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9" r:id="rId3"/>
    <p:sldId id="263" r:id="rId4"/>
    <p:sldId id="291" r:id="rId5"/>
    <p:sldId id="262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Figures" id="{5E637066-4B4B-4FC5-A509-1797C1E8025D}">
          <p14:sldIdLst>
            <p14:sldId id="256"/>
            <p14:sldId id="259"/>
            <p14:sldId id="263"/>
            <p14:sldId id="291"/>
          </p14:sldIdLst>
        </p14:section>
        <p14:section name="Tables" id="{F7782BEE-2EE6-49C8-9FE5-658B6F859985}">
          <p14:sldIdLst>
            <p14:sldId id="262"/>
            <p14:sldId id="26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50" d="100"/>
          <a:sy n="150" d="100"/>
        </p:scale>
        <p:origin x="5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D752B-CB17-4814-B2C0-DF3F484BEB7F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ECDE51-60D2-4EAE-BFC6-9CD8C57A07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780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145c26e9ee6_0_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145c26e9ee6_0_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A87469-C8D6-7D71-B5D1-0E35E4E186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A0E880-6F6E-5A90-1A9E-5FEDCB1A14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057C91-769E-C07E-ED62-56B2EF658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61192D-ABB4-963A-EE4B-F991C2330E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EB2B3-5F6E-CC5C-015F-FFF7AA7A3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435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19FD67-A8A3-45DC-7128-7C10E3AD04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0B3A4A-CFEB-9733-E273-4852456B1D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96B4FB-AEB7-91D8-D727-50030DAC0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47D632-5511-D352-7508-2C96A613B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8A2DBC-EBBF-2997-0249-5C67FA95B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637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A779BB-0552-3664-D5CF-67E9ECFE06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BEBC45-8C7B-A2E3-3310-D0B68DBACF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59E0A8-DBA0-D95D-D28D-03F25DAEC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CF7684-753C-7C58-3479-99563ECB7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546773-54AF-47C9-666C-C7CAF7794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32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E6A677-B152-195B-FBE5-BC84AFEC9C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B93FD4-DEF7-A842-94F0-832100F635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4097E5-E8BA-6CD3-A4EA-F17159F44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CF62DF-93C6-1C20-D14A-AA7CF384E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3CFB50-A28D-DEE1-49FD-E61D70B66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707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0EB063-B144-3671-EFE3-A64CC29677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429347-D884-E996-82B3-7E1CD287BD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726C65-CA21-5F56-76B0-4077DA61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9723AA-B120-4251-E380-8E15B9C71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E14502-71EE-3404-D7DD-6F839AE7C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539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07485B-C851-B07E-C46C-CC88261543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768D60-F746-0BD4-0891-FA0A0FC07B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A0A4F9-41DD-686F-9F3C-4E46620EA8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BE7A51-115A-4FD5-096E-B28B69C18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4767EC-87F9-0F51-9582-CD0EAE988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D3050E-C2D1-9149-13AA-40568B05B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825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DE942-202D-ABCB-7BFF-2A16E1A7E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6C20C8-B0C2-81FA-F8B6-EF366CC66F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C30D53-055E-4EDB-6077-4B87557580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3AB2FB-AC27-9ED5-B79A-867CEF93DD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5FCF4B-B02F-F369-656A-A14CAE33F6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EEBA704-0B09-B3B7-6BBC-C5676DECA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ED00AC7-6F9F-4B50-C574-BAABDF5C9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FA118C3-2550-4DD2-8661-F9C93469B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148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580EB6-28A5-F3F3-F68B-B4885BBD6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BD48112-AD9A-77AE-8235-8C5CD32E2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085B04-2F79-73BC-25EA-B89807D0E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762754-1B5D-050B-D7B2-4E37B3478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633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0C0EED-3F12-ED3A-BE0D-DCE2955D9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82E5EF-0DA3-EBCA-91BE-9A7930E013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0EA2AA-4BDE-D761-39D4-5693B7711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79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51AE1F-282B-E746-EFED-2ADEA3CA2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6BC07A-1065-9263-3B97-5962381439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D35213-58C7-F668-E502-3E80DA715F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A097F1-5F9F-DAA9-8A69-6641967C1A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89117B-F63F-D386-0E3C-B2A0F7BC9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7D1749-DD5C-3772-3E8B-F965E6ECF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935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8ED83F-74FD-3886-BF31-B2705A9746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42B7DB1-67FF-E76D-1316-17F4861C53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F6470D-FC56-2097-0595-A87DAAA206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662355-5A92-39CC-CEEF-3B39F36F5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265F4B-3FBA-733C-BD79-D57B4EF9B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BBBC00-CF5B-B9E8-DCF4-71FF10E54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75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C92797-3B2C-1005-2134-015556A98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8E1751-FD27-9337-E424-7FFA4400DA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A6BB5C-24B2-A4D0-CCF3-175BCCA828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FBCBC-55FC-4DA2-B693-DC1C471E18F0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C9C0DF-5263-8137-D760-27F42C76A9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175EC6-9AE8-A54C-A9A2-3ED5542F7A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765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20.png"/><Relationship Id="rId3" Type="http://schemas.openxmlformats.org/officeDocument/2006/relationships/image" Target="../media/image13.png"/><Relationship Id="rId7" Type="http://schemas.openxmlformats.org/officeDocument/2006/relationships/image" Target="../media/image16.png"/><Relationship Id="rId12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image" Target="../media/image18.png"/><Relationship Id="rId5" Type="http://schemas.openxmlformats.org/officeDocument/2006/relationships/image" Target="../media/image15.png"/><Relationship Id="rId10" Type="http://schemas.openxmlformats.org/officeDocument/2006/relationships/image" Target="../media/image9.png"/><Relationship Id="rId4" Type="http://schemas.openxmlformats.org/officeDocument/2006/relationships/image" Target="../media/image6.png"/><Relationship Id="rId9" Type="http://schemas.openxmlformats.org/officeDocument/2006/relationships/image" Target="../media/image17.png"/><Relationship Id="rId1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1FC50405-C6EF-1FC7-60C6-880A0293CC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3856"/>
            <a:ext cx="12192000" cy="611028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3CA373A-28C0-51FC-02D0-242C12A015AB}"/>
              </a:ext>
            </a:extLst>
          </p:cNvPr>
          <p:cNvSpPr txBox="1"/>
          <p:nvPr/>
        </p:nvSpPr>
        <p:spPr>
          <a:xfrm>
            <a:off x="0" y="6611779"/>
            <a:ext cx="121920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Figure 1.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 Search criteria to filter the ADNI-3 dataset. From the results of this search, 89 Axial T</a:t>
            </a:r>
            <a:r>
              <a:rPr lang="en-US" sz="1000" i="1" baseline="-25000" dirty="0">
                <a:latin typeface="Roboto" panose="02000000000000000000" pitchFamily="2" charset="0"/>
                <a:ea typeface="Roboto" panose="02000000000000000000" pitchFamily="2" charset="0"/>
              </a:rPr>
              <a:t>2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* samples from different subjects were randomly chosen.</a:t>
            </a:r>
          </a:p>
        </p:txBody>
      </p:sp>
    </p:spTree>
    <p:extLst>
      <p:ext uri="{BB962C8B-B14F-4D97-AF65-F5344CB8AC3E}">
        <p14:creationId xmlns:p14="http://schemas.microsoft.com/office/powerpoint/2010/main" val="5462763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5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ctr" anchorCtr="0">
            <a:normAutofit/>
          </a:bodyPr>
          <a:lstStyle/>
          <a:p>
            <a:fld id="{00000000-1234-1234-1234-123412341234}" type="slidenum">
              <a:rPr lang="en"/>
              <a:pPr/>
              <a:t>2</a:t>
            </a:fld>
            <a:endParaRPr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F5EA359-C795-0B56-22C5-54281669E82E}"/>
              </a:ext>
            </a:extLst>
          </p:cNvPr>
          <p:cNvGrpSpPr/>
          <p:nvPr/>
        </p:nvGrpSpPr>
        <p:grpSpPr>
          <a:xfrm>
            <a:off x="2730018" y="0"/>
            <a:ext cx="6731964" cy="6393329"/>
            <a:chOff x="969433" y="23185"/>
            <a:chExt cx="6731964" cy="6393329"/>
          </a:xfrm>
        </p:grpSpPr>
        <p:pic>
          <p:nvPicPr>
            <p:cNvPr id="70" name="Google Shape;70;p15"/>
            <p:cNvPicPr preferRelativeResize="0"/>
            <p:nvPr/>
          </p:nvPicPr>
          <p:blipFill rotWithShape="1">
            <a:blip r:embed="rId3">
              <a:alphaModFix/>
            </a:blip>
            <a:srcRect l="11159" t="13527" r="7973" b="15013"/>
            <a:stretch/>
          </p:blipFill>
          <p:spPr>
            <a:xfrm>
              <a:off x="1447433" y="23185"/>
              <a:ext cx="6253964" cy="300606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1" name="Google Shape;71;p15"/>
            <p:cNvPicPr preferRelativeResize="0"/>
            <p:nvPr/>
          </p:nvPicPr>
          <p:blipFill rotWithShape="1">
            <a:blip r:embed="rId4">
              <a:alphaModFix/>
            </a:blip>
            <a:srcRect l="9380" t="11001" r="9258" b="8696"/>
            <a:stretch/>
          </p:blipFill>
          <p:spPr>
            <a:xfrm>
              <a:off x="1447433" y="3059067"/>
              <a:ext cx="6253964" cy="335744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3" name="Google Shape;73;p15"/>
            <p:cNvSpPr txBox="1"/>
            <p:nvPr/>
          </p:nvSpPr>
          <p:spPr>
            <a:xfrm>
              <a:off x="969433" y="32750"/>
              <a:ext cx="478000" cy="492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/>
              <a:r>
                <a:rPr lang="en" sz="1600" b="1" dirty="0">
                  <a:latin typeface="Roboto"/>
                  <a:ea typeface="Roboto"/>
                  <a:cs typeface="Roboto"/>
                  <a:sym typeface="Roboto"/>
                </a:rPr>
                <a:t>a)</a:t>
              </a:r>
              <a:endParaRPr sz="1600" b="1" dirty="0">
                <a:latin typeface="Roboto"/>
                <a:ea typeface="Roboto"/>
                <a:cs typeface="Roboto"/>
                <a:sym typeface="Roboto"/>
              </a:endParaRPr>
            </a:p>
          </p:txBody>
        </p:sp>
        <p:sp>
          <p:nvSpPr>
            <p:cNvPr id="74" name="Google Shape;74;p15"/>
            <p:cNvSpPr txBox="1"/>
            <p:nvPr/>
          </p:nvSpPr>
          <p:spPr>
            <a:xfrm>
              <a:off x="969433" y="3059067"/>
              <a:ext cx="478000" cy="492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/>
              <a:r>
                <a:rPr lang="en" sz="1600" b="1" dirty="0">
                  <a:latin typeface="Roboto"/>
                  <a:ea typeface="Roboto"/>
                  <a:cs typeface="Roboto"/>
                  <a:sym typeface="Roboto"/>
                </a:rPr>
                <a:t>b)</a:t>
              </a:r>
              <a:endParaRPr sz="1600" b="1" dirty="0">
                <a:latin typeface="Roboto"/>
                <a:ea typeface="Roboto"/>
                <a:cs typeface="Roboto"/>
                <a:sym typeface="Roboto"/>
              </a:endParaRPr>
            </a:p>
          </p:txBody>
        </p:sp>
      </p:grpSp>
      <p:sp>
        <p:nvSpPr>
          <p:cNvPr id="72" name="Google Shape;72;p15"/>
          <p:cNvSpPr txBox="1"/>
          <p:nvPr/>
        </p:nvSpPr>
        <p:spPr>
          <a:xfrm>
            <a:off x="0" y="6304043"/>
            <a:ext cx="12192000" cy="5539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spAutoFit/>
          </a:bodyPr>
          <a:lstStyle/>
          <a:p>
            <a:pPr algn="just"/>
            <a:r>
              <a:rPr lang="en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Figure 2:</a:t>
            </a:r>
            <a:r>
              <a:rPr lang="en" sz="1000" i="1" dirty="0">
                <a:latin typeface="Roboto" panose="02000000000000000000" pitchFamily="2" charset="0"/>
                <a:ea typeface="Roboto" panose="02000000000000000000" pitchFamily="2" charset="0"/>
              </a:rPr>
              <a:t> Iterative local SNR-guided approach to determine noise scaling factor for forward simulation of native noise corrupted data. </a:t>
            </a:r>
            <a:r>
              <a:rPr lang="en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(a)</a:t>
            </a:r>
            <a:r>
              <a:rPr lang="en" sz="1000" i="1" dirty="0">
                <a:latin typeface="Roboto" panose="02000000000000000000" pitchFamily="2" charset="0"/>
                <a:ea typeface="Roboto" panose="02000000000000000000" pitchFamily="2" charset="0"/>
              </a:rPr>
              <a:t> Representative </a:t>
            </a:r>
            <a:r>
              <a:rPr lang="en" sz="1000" i="1" dirty="0">
                <a:solidFill>
                  <a:schemeClr val="dk1"/>
                </a:solidFill>
                <a:latin typeface="Roboto" panose="02000000000000000000" pitchFamily="2" charset="0"/>
                <a:ea typeface="Roboto" panose="02000000000000000000" pitchFamily="2" charset="0"/>
              </a:rPr>
              <a:t>center slices of </a:t>
            </a:r>
            <a:r>
              <a:rPr lang="en" sz="1000" i="1" dirty="0">
                <a:latin typeface="Roboto" panose="02000000000000000000" pitchFamily="2" charset="0"/>
                <a:ea typeface="Roboto" panose="02000000000000000000" pitchFamily="2" charset="0"/>
              </a:rPr>
              <a:t>brain-masked local SNR map of Fastest (left) and IXI (right). Black boxes indicate regions of interest (ROIs). </a:t>
            </a:r>
            <a:r>
              <a:rPr lang="en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(b)</a:t>
            </a:r>
            <a:r>
              <a:rPr lang="en" sz="1000" i="1" dirty="0">
                <a:latin typeface="Roboto" panose="02000000000000000000" pitchFamily="2" charset="0"/>
                <a:ea typeface="Roboto" panose="02000000000000000000" pitchFamily="2" charset="0"/>
              </a:rPr>
              <a:t> Minimum, maximum and mean(dashed) of local SNR values within the ROIs, across central 50% slab of Fastest and IXI.</a:t>
            </a:r>
            <a:endParaRPr sz="1000" i="1" dirty="0">
              <a:latin typeface="Roboto" panose="02000000000000000000" pitchFamily="2" charset="0"/>
              <a:ea typeface="Roboto" panose="02000000000000000000" pitchFamily="2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529D95B-0BC2-30F3-5CDB-1EC4F1CD4E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7418286"/>
              </p:ext>
            </p:extLst>
          </p:nvPr>
        </p:nvGraphicFramePr>
        <p:xfrm>
          <a:off x="1402430" y="14289"/>
          <a:ext cx="9387141" cy="6265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10231456" imgH="6828881" progId="Prism9.Document">
                  <p:embed/>
                </p:oleObj>
              </mc:Choice>
              <mc:Fallback>
                <p:oleObj name="Prism 9" r:id="rId2" imgW="10231456" imgH="682888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02430" y="14289"/>
                        <a:ext cx="9387141" cy="6265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7EC01CE-537F-AB76-884E-EACD805F9DEA}"/>
              </a:ext>
            </a:extLst>
          </p:cNvPr>
          <p:cNvSpPr txBox="1"/>
          <p:nvPr/>
        </p:nvSpPr>
        <p:spPr>
          <a:xfrm>
            <a:off x="0" y="6457890"/>
            <a:ext cx="12192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Figure 3.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 Training histories of the contrast-specific image baseline denoising models as a function of training epochs. The dashed lines represent the corresponding validation losses. Training durations (</a:t>
            </a:r>
            <a:r>
              <a:rPr lang="en-US" sz="1000" i="1" dirty="0" err="1">
                <a:latin typeface="Roboto" panose="02000000000000000000" pitchFamily="2" charset="0"/>
                <a:ea typeface="Roboto" panose="02000000000000000000" pitchFamily="2" charset="0"/>
              </a:rPr>
              <a:t>hh:mm:ss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) are presented in brackets in the figure legend.</a:t>
            </a:r>
          </a:p>
        </p:txBody>
      </p:sp>
    </p:spTree>
    <p:extLst>
      <p:ext uri="{BB962C8B-B14F-4D97-AF65-F5344CB8AC3E}">
        <p14:creationId xmlns:p14="http://schemas.microsoft.com/office/powerpoint/2010/main" val="4186255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46F9AC07-58BA-3088-D5F3-D142B006F963}"/>
              </a:ext>
            </a:extLst>
          </p:cNvPr>
          <p:cNvSpPr txBox="1"/>
          <p:nvPr/>
        </p:nvSpPr>
        <p:spPr>
          <a:xfrm>
            <a:off x="1843714" y="0"/>
            <a:ext cx="85045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Visualizing select intermediate layer outputs for five threshold values to understand the denoising mechanism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A472D34-4474-43F4-037A-1371185207A9}"/>
              </a:ext>
            </a:extLst>
          </p:cNvPr>
          <p:cNvSpPr txBox="1"/>
          <p:nvPr/>
        </p:nvSpPr>
        <p:spPr>
          <a:xfrm>
            <a:off x="0" y="6449200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Figure 4.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 Select intermediate 2D convolutional layer outputs for the originally chosen threshold value (highlighted in green), and the five additional threshold values: 0.50, 0.60, 0.70, 0.80, and 0.90. The outputs for 0.50 and 0.60 contained excessive high-frequency content, while a large number of values were </a:t>
            </a:r>
            <a:r>
              <a:rPr lang="en-US" sz="1000" i="1">
                <a:latin typeface="Roboto" panose="02000000000000000000" pitchFamily="2" charset="0"/>
                <a:ea typeface="Roboto" panose="02000000000000000000" pitchFamily="2" charset="0"/>
              </a:rPr>
              <a:t>zeroed-out in the 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outputs for 0.80 and 0.90.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9653DF0F-0A57-76F9-C30E-B089AD9A8C15}"/>
              </a:ext>
            </a:extLst>
          </p:cNvPr>
          <p:cNvGrpSpPr/>
          <p:nvPr/>
        </p:nvGrpSpPr>
        <p:grpSpPr>
          <a:xfrm>
            <a:off x="4927754" y="1368032"/>
            <a:ext cx="2336494" cy="1705564"/>
            <a:chOff x="6477003" y="878491"/>
            <a:chExt cx="2336494" cy="170556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5CB26BB-B2EC-8224-CDE7-84BD46FC94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0979" b="75870"/>
            <a:stretch/>
          </p:blipFill>
          <p:spPr>
            <a:xfrm>
              <a:off x="6477003" y="1186268"/>
              <a:ext cx="2336494" cy="1397787"/>
            </a:xfrm>
            <a:prstGeom prst="rect">
              <a:avLst/>
            </a:prstGeom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09B45FF-037C-8BDD-1560-69BF98E52326}"/>
                    </a:ext>
                  </a:extLst>
                </p:cNvPr>
                <p:cNvSpPr txBox="1"/>
                <p:nvPr/>
              </p:nvSpPr>
              <p:spPr>
                <a:xfrm>
                  <a:off x="7338371" y="878491"/>
                  <a:ext cx="61375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𝟎</m:t>
                        </m:r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.</m:t>
                        </m:r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𝟔𝟎</m:t>
                        </m:r>
                      </m:oMath>
                    </m:oMathPara>
                  </a14:m>
                  <a:endParaRPr lang="en-US" sz="1400" b="1" dirty="0"/>
                </a:p>
              </p:txBody>
            </p:sp>
          </mc:Choice>
          <mc:Fallback xmlns=""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09B45FF-037C-8BDD-1560-69BF98E52326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7338371" y="878491"/>
                  <a:ext cx="613758" cy="307777"/>
                </a:xfrm>
                <a:prstGeom prst="rect">
                  <a:avLst/>
                </a:prstGeom>
                <a:blipFill>
                  <a:blip r:embed="rId3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8CAE529A-4DE7-9E86-A856-9307E25AF0B2}"/>
              </a:ext>
            </a:extLst>
          </p:cNvPr>
          <p:cNvGrpSpPr/>
          <p:nvPr/>
        </p:nvGrpSpPr>
        <p:grpSpPr>
          <a:xfrm>
            <a:off x="4927754" y="3317875"/>
            <a:ext cx="2336494" cy="1756364"/>
            <a:chOff x="5219700" y="3253784"/>
            <a:chExt cx="2336494" cy="175636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AF3681F-6508-21A6-316E-776BC17CCE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0979" b="74993"/>
            <a:stretch/>
          </p:blipFill>
          <p:spPr>
            <a:xfrm>
              <a:off x="5219700" y="3561561"/>
              <a:ext cx="2336494" cy="1448587"/>
            </a:xfrm>
            <a:prstGeom prst="rect">
              <a:avLst/>
            </a:prstGeom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E2E7BF51-A7BB-AB3D-39AB-B8D36C755649}"/>
                    </a:ext>
                  </a:extLst>
                </p:cNvPr>
                <p:cNvSpPr txBox="1"/>
                <p:nvPr/>
              </p:nvSpPr>
              <p:spPr>
                <a:xfrm>
                  <a:off x="6081068" y="3253784"/>
                  <a:ext cx="61375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𝟎</m:t>
                        </m:r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.</m:t>
                        </m:r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𝟖𝟎</m:t>
                        </m:r>
                      </m:oMath>
                    </m:oMathPara>
                  </a14:m>
                  <a:endParaRPr lang="en-US" sz="1400" b="1" dirty="0"/>
                </a:p>
              </p:txBody>
            </p:sp>
          </mc:Choice>
          <mc:Fallback xmlns=""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E2E7BF51-A7BB-AB3D-39AB-B8D36C755649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081068" y="3253784"/>
                  <a:ext cx="613758" cy="307777"/>
                </a:xfrm>
                <a:prstGeom prst="rect">
                  <a:avLst/>
                </a:prstGeom>
                <a:blipFill>
                  <a:blip r:embed="rId5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C380C53F-53B7-BB3D-7F27-D6E7DB7CDB53}"/>
              </a:ext>
            </a:extLst>
          </p:cNvPr>
          <p:cNvGrpSpPr/>
          <p:nvPr/>
        </p:nvGrpSpPr>
        <p:grpSpPr>
          <a:xfrm>
            <a:off x="7322509" y="1342633"/>
            <a:ext cx="2336494" cy="1756365"/>
            <a:chOff x="2019605" y="3253784"/>
            <a:chExt cx="2336494" cy="175636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0C75DA0-B16C-D1F2-F07F-BF0177CA2F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0979" b="74993"/>
            <a:stretch/>
          </p:blipFill>
          <p:spPr>
            <a:xfrm>
              <a:off x="2019605" y="3561562"/>
              <a:ext cx="2336494" cy="1448587"/>
            </a:xfrm>
            <a:prstGeom prst="rect">
              <a:avLst/>
            </a:prstGeom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F4AA7E28-F308-C281-D411-932E4EF6067A}"/>
                    </a:ext>
                  </a:extLst>
                </p:cNvPr>
                <p:cNvSpPr txBox="1"/>
                <p:nvPr/>
              </p:nvSpPr>
              <p:spPr>
                <a:xfrm>
                  <a:off x="2880973" y="3253784"/>
                  <a:ext cx="61375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𝟎</m:t>
                        </m:r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.</m:t>
                        </m:r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𝟕𝟎</m:t>
                        </m:r>
                      </m:oMath>
                    </m:oMathPara>
                  </a14:m>
                  <a:endParaRPr lang="en-US" sz="1400" b="1" dirty="0"/>
                </a:p>
              </p:txBody>
            </p:sp>
          </mc:Choice>
          <mc:Fallback xmlns=""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F4AA7E28-F308-C281-D411-932E4EF6067A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880973" y="3253784"/>
                  <a:ext cx="613758" cy="307777"/>
                </a:xfrm>
                <a:prstGeom prst="rect">
                  <a:avLst/>
                </a:prstGeom>
                <a:blipFill>
                  <a:blip r:embed="rId7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41CC0D58-2206-084C-8F3C-3786823411BD}"/>
              </a:ext>
            </a:extLst>
          </p:cNvPr>
          <p:cNvGrpSpPr/>
          <p:nvPr/>
        </p:nvGrpSpPr>
        <p:grpSpPr>
          <a:xfrm>
            <a:off x="7322509" y="3339202"/>
            <a:ext cx="2336494" cy="1735037"/>
            <a:chOff x="8419795" y="3275111"/>
            <a:chExt cx="2336494" cy="1735037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64AF70D-F506-210B-D051-A50638B89F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0979" b="74993"/>
            <a:stretch/>
          </p:blipFill>
          <p:spPr>
            <a:xfrm>
              <a:off x="8419795" y="3561561"/>
              <a:ext cx="2336494" cy="1448587"/>
            </a:xfrm>
            <a:prstGeom prst="rect">
              <a:avLst/>
            </a:prstGeom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02220678-CE92-683D-1CD7-ED9CB60CDFE5}"/>
                    </a:ext>
                  </a:extLst>
                </p:cNvPr>
                <p:cNvSpPr txBox="1"/>
                <p:nvPr/>
              </p:nvSpPr>
              <p:spPr>
                <a:xfrm>
                  <a:off x="9281163" y="3275111"/>
                  <a:ext cx="61375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𝟎</m:t>
                        </m:r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.</m:t>
                        </m:r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𝟗𝟎</m:t>
                        </m:r>
                      </m:oMath>
                    </m:oMathPara>
                  </a14:m>
                  <a:endParaRPr lang="en-US" sz="1400" b="1" dirty="0"/>
                </a:p>
              </p:txBody>
            </p:sp>
          </mc:Choice>
          <mc:Fallback xmlns=""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02220678-CE92-683D-1CD7-ED9CB60CDFE5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9281163" y="3275111"/>
                  <a:ext cx="613758" cy="307777"/>
                </a:xfrm>
                <a:prstGeom prst="rect">
                  <a:avLst/>
                </a:prstGeom>
                <a:blipFill>
                  <a:blip r:embed="rId9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B47C75A0-5FCE-1B1E-ADC8-2BB1F4F4A6F7}"/>
              </a:ext>
            </a:extLst>
          </p:cNvPr>
          <p:cNvGrpSpPr/>
          <p:nvPr/>
        </p:nvGrpSpPr>
        <p:grpSpPr>
          <a:xfrm>
            <a:off x="2532999" y="1342633"/>
            <a:ext cx="2336494" cy="1756364"/>
            <a:chOff x="3378505" y="853092"/>
            <a:chExt cx="2336494" cy="175636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839EA2E-F28C-78A9-AEE6-2992596E5B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0979" b="74993"/>
            <a:stretch/>
          </p:blipFill>
          <p:spPr>
            <a:xfrm>
              <a:off x="3378505" y="1160869"/>
              <a:ext cx="2336494" cy="1448587"/>
            </a:xfrm>
            <a:prstGeom prst="rect">
              <a:avLst/>
            </a:prstGeom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2AD5477C-803F-7DD3-B561-EAC3DFB36F41}"/>
                    </a:ext>
                  </a:extLst>
                </p:cNvPr>
                <p:cNvSpPr txBox="1"/>
                <p:nvPr/>
              </p:nvSpPr>
              <p:spPr>
                <a:xfrm>
                  <a:off x="4239873" y="853092"/>
                  <a:ext cx="61375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𝟎</m:t>
                        </m:r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.</m:t>
                        </m:r>
                        <m:r>
                          <a:rPr lang="en-US" sz="1400" b="1" i="1" smtClean="0">
                            <a:latin typeface="Cambria Math" panose="02040503050406030204" pitchFamily="18" charset="0"/>
                          </a:rPr>
                          <m:t>𝟓𝟎</m:t>
                        </m:r>
                      </m:oMath>
                    </m:oMathPara>
                  </a14:m>
                  <a:endParaRPr lang="en-US" sz="1400" b="1" dirty="0"/>
                </a:p>
              </p:txBody>
            </p:sp>
          </mc:Choice>
          <mc:Fallback xmlns=""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2AD5477C-803F-7DD3-B561-EAC3DFB36F41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239873" y="853092"/>
                  <a:ext cx="613758" cy="307777"/>
                </a:xfrm>
                <a:prstGeom prst="rect">
                  <a:avLst/>
                </a:prstGeom>
                <a:blipFill>
                  <a:blip r:embed="rId11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E71BD23E-8026-3BEE-E3B4-F72CAC016534}"/>
              </a:ext>
            </a:extLst>
          </p:cNvPr>
          <p:cNvGrpSpPr/>
          <p:nvPr/>
        </p:nvGrpSpPr>
        <p:grpSpPr>
          <a:xfrm>
            <a:off x="2532997" y="3317875"/>
            <a:ext cx="2336496" cy="2197493"/>
            <a:chOff x="2532997" y="3317875"/>
            <a:chExt cx="2336496" cy="2197493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574BA89F-F950-2131-435B-6BE1860A2B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1216" b="75212"/>
            <a:stretch/>
          </p:blipFill>
          <p:spPr>
            <a:xfrm>
              <a:off x="2542524" y="3638352"/>
              <a:ext cx="2317445" cy="1435887"/>
            </a:xfrm>
            <a:prstGeom prst="rect">
              <a:avLst/>
            </a:prstGeom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4A50E192-4542-D60A-C488-7633A62FCE14}"/>
                    </a:ext>
                  </a:extLst>
                </p:cNvPr>
                <p:cNvSpPr txBox="1"/>
                <p:nvPr/>
              </p:nvSpPr>
              <p:spPr>
                <a:xfrm>
                  <a:off x="3394367" y="3339201"/>
                  <a:ext cx="61375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1400" b="1" i="1" smtClean="0">
                            <a:solidFill>
                              <a:schemeClr val="accent6">
                                <a:lumMod val="75000"/>
                              </a:schemeClr>
                            </a:solidFill>
                            <a:latin typeface="Cambria Math" panose="02040503050406030204" pitchFamily="18" charset="0"/>
                          </a:rPr>
                          <m:t>𝟎</m:t>
                        </m:r>
                        <m:r>
                          <a:rPr lang="en-US" sz="1400" b="1" i="1" smtClean="0">
                            <a:solidFill>
                              <a:schemeClr val="accent6">
                                <a:lumMod val="75000"/>
                              </a:schemeClr>
                            </a:solidFill>
                            <a:latin typeface="Cambria Math" panose="02040503050406030204" pitchFamily="18" charset="0"/>
                          </a:rPr>
                          <m:t>.</m:t>
                        </m:r>
                        <m:r>
                          <a:rPr lang="en-US" sz="1400" b="1" i="1" smtClean="0">
                            <a:solidFill>
                              <a:schemeClr val="accent6">
                                <a:lumMod val="75000"/>
                              </a:schemeClr>
                            </a:solidFill>
                            <a:latin typeface="Cambria Math" panose="02040503050406030204" pitchFamily="18" charset="0"/>
                          </a:rPr>
                          <m:t>𝟕𝟓</m:t>
                        </m:r>
                      </m:oMath>
                    </m:oMathPara>
                  </a14:m>
                  <a:endParaRPr lang="en-US" sz="1400" b="1" dirty="0">
                    <a:solidFill>
                      <a:schemeClr val="accent6">
                        <a:lumMod val="75000"/>
                      </a:schemeClr>
                    </a:solidFill>
                  </a:endParaRPr>
                </a:p>
              </p:txBody>
            </p:sp>
          </mc:Choice>
          <mc:Fallback xmlns=""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4A50E192-4542-D60A-C488-7633A62FCE14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3394367" y="3339201"/>
                  <a:ext cx="613758" cy="307777"/>
                </a:xfrm>
                <a:prstGeom prst="rect">
                  <a:avLst/>
                </a:prstGeom>
                <a:blipFill>
                  <a:blip r:embed="rId13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B42C7D7B-1261-82F0-98DC-9DF490CF4492}"/>
                    </a:ext>
                  </a:extLst>
                </p:cNvPr>
                <p:cNvSpPr txBox="1"/>
                <p:nvPr/>
              </p:nvSpPr>
              <p:spPr>
                <a:xfrm>
                  <a:off x="2959972" y="5207591"/>
                  <a:ext cx="154080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m:rPr>
                            <m:nor/>
                          </m:rPr>
                          <a:rPr lang="en-US" sz="1400" b="1" i="0" smtClean="0">
                            <a:solidFill>
                              <a:schemeClr val="accent6">
                                <a:lumMod val="75000"/>
                              </a:schemeClr>
                            </a:solidFill>
                            <a:latin typeface="Cambria Math" panose="02040503050406030204" pitchFamily="18" charset="0"/>
                          </a:rPr>
                          <m:t>Chosen</m:t>
                        </m:r>
                        <m:r>
                          <m:rPr>
                            <m:nor/>
                          </m:rPr>
                          <a:rPr lang="en-US" sz="1400" b="1" i="0" smtClean="0">
                            <a:solidFill>
                              <a:schemeClr val="accent6">
                                <a:lumMod val="75000"/>
                              </a:schemeClr>
                            </a:solidFill>
                            <a:latin typeface="Cambria Math" panose="02040503050406030204" pitchFamily="18" charset="0"/>
                          </a:rPr>
                          <m:t> </m:t>
                        </m:r>
                        <m:r>
                          <m:rPr>
                            <m:nor/>
                          </m:rPr>
                          <a:rPr lang="en-US" sz="1400" b="1" i="0" smtClean="0">
                            <a:solidFill>
                              <a:schemeClr val="accent6">
                                <a:lumMod val="75000"/>
                              </a:schemeClr>
                            </a:solidFill>
                            <a:latin typeface="Cambria Math" panose="02040503050406030204" pitchFamily="18" charset="0"/>
                          </a:rPr>
                          <m:t>threshold</m:t>
                        </m:r>
                      </m:oMath>
                    </m:oMathPara>
                  </a14:m>
                  <a:endParaRPr lang="en-US" sz="1400" b="1" dirty="0">
                    <a:solidFill>
                      <a:schemeClr val="accent6">
                        <a:lumMod val="75000"/>
                      </a:schemeClr>
                    </a:solidFill>
                  </a:endParaRPr>
                </a:p>
              </p:txBody>
            </p:sp>
          </mc:Choice>
          <mc:Fallback xmlns=""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B42C7D7B-1261-82F0-98DC-9DF490CF4492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959972" y="5207591"/>
                  <a:ext cx="1540806" cy="307777"/>
                </a:xfrm>
                <a:prstGeom prst="rect">
                  <a:avLst/>
                </a:prstGeom>
                <a:blipFill>
                  <a:blip r:embed="rId14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70C3CE1E-C27A-9556-FC96-EBD7C79AADE4}"/>
                </a:ext>
              </a:extLst>
            </p:cNvPr>
            <p:cNvSpPr/>
            <p:nvPr/>
          </p:nvSpPr>
          <p:spPr>
            <a:xfrm>
              <a:off x="2532997" y="3317875"/>
              <a:ext cx="2336496" cy="1889716"/>
            </a:xfrm>
            <a:prstGeom prst="rect">
              <a:avLst/>
            </a:prstGeom>
            <a:noFill/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8968325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DD43BD2-BD21-35DD-2D20-5028064752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1426245"/>
              </p:ext>
            </p:extLst>
          </p:nvPr>
        </p:nvGraphicFramePr>
        <p:xfrm>
          <a:off x="3948113" y="2034540"/>
          <a:ext cx="4295775" cy="265176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333375">
                  <a:extLst>
                    <a:ext uri="{9D8B030D-6E8A-4147-A177-3AD203B41FA5}">
                      <a16:colId xmlns:a16="http://schemas.microsoft.com/office/drawing/2014/main" val="711942888"/>
                    </a:ext>
                  </a:extLst>
                </a:gridCol>
                <a:gridCol w="2867025">
                  <a:extLst>
                    <a:ext uri="{9D8B030D-6E8A-4147-A177-3AD203B41FA5}">
                      <a16:colId xmlns:a16="http://schemas.microsoft.com/office/drawing/2014/main" val="3028515039"/>
                    </a:ext>
                  </a:extLst>
                </a:gridCol>
                <a:gridCol w="1095375">
                  <a:extLst>
                    <a:ext uri="{9D8B030D-6E8A-4147-A177-3AD203B41FA5}">
                      <a16:colId xmlns:a16="http://schemas.microsoft.com/office/drawing/2014/main" val="349271615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#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Degrees of freedom (DOF)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Weigh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00039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1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TR – Repetition time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10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6116739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2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ETL – Echo Train Length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9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260534647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3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Dir – Diffusion directions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8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755155363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4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ST – Slice thickness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7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595265280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5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ARC – Acceleration factor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6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27925299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6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ASSET – Acceleration factor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5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658473355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7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NEX – Number of averages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40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1955952480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8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 err="1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rSNR</a:t>
                      </a: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 – Relative SNR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30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69999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C8E9493-EE7A-877D-2E3B-D580A1B3877B}"/>
              </a:ext>
            </a:extLst>
          </p:cNvPr>
          <p:cNvSpPr txBox="1"/>
          <p:nvPr/>
        </p:nvSpPr>
        <p:spPr>
          <a:xfrm>
            <a:off x="1060006" y="6611779"/>
            <a:ext cx="100719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Table 1.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 Degrees of freedom (DOF) and their corresponding weights. DOF contributing more significantly to the image contrast are assigned higher weight values.</a:t>
            </a:r>
          </a:p>
        </p:txBody>
      </p:sp>
    </p:spTree>
    <p:extLst>
      <p:ext uri="{BB962C8B-B14F-4D97-AF65-F5344CB8AC3E}">
        <p14:creationId xmlns:p14="http://schemas.microsoft.com/office/powerpoint/2010/main" val="3991442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0700478-1A26-2C8D-A4F3-CE8F23B620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0059313"/>
              </p:ext>
            </p:extLst>
          </p:nvPr>
        </p:nvGraphicFramePr>
        <p:xfrm>
          <a:off x="2593976" y="2209800"/>
          <a:ext cx="7004049" cy="260604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383034">
                  <a:extLst>
                    <a:ext uri="{9D8B030D-6E8A-4147-A177-3AD203B41FA5}">
                      <a16:colId xmlns:a16="http://schemas.microsoft.com/office/drawing/2014/main" val="3162675754"/>
                    </a:ext>
                  </a:extLst>
                </a:gridCol>
                <a:gridCol w="1324203">
                  <a:extLst>
                    <a:ext uri="{9D8B030D-6E8A-4147-A177-3AD203B41FA5}">
                      <a16:colId xmlns:a16="http://schemas.microsoft.com/office/drawing/2014/main" val="3206331612"/>
                    </a:ext>
                  </a:extLst>
                </a:gridCol>
                <a:gridCol w="1324203">
                  <a:extLst>
                    <a:ext uri="{9D8B030D-6E8A-4147-A177-3AD203B41FA5}">
                      <a16:colId xmlns:a16="http://schemas.microsoft.com/office/drawing/2014/main" val="4185073598"/>
                    </a:ext>
                  </a:extLst>
                </a:gridCol>
                <a:gridCol w="1096060">
                  <a:extLst>
                    <a:ext uri="{9D8B030D-6E8A-4147-A177-3AD203B41FA5}">
                      <a16:colId xmlns:a16="http://schemas.microsoft.com/office/drawing/2014/main" val="1944660635"/>
                    </a:ext>
                  </a:extLst>
                </a:gridCol>
                <a:gridCol w="1562100">
                  <a:extLst>
                    <a:ext uri="{9D8B030D-6E8A-4147-A177-3AD203B41FA5}">
                      <a16:colId xmlns:a16="http://schemas.microsoft.com/office/drawing/2014/main" val="710645720"/>
                    </a:ext>
                  </a:extLst>
                </a:gridCol>
                <a:gridCol w="1314449">
                  <a:extLst>
                    <a:ext uri="{9D8B030D-6E8A-4147-A177-3AD203B41FA5}">
                      <a16:colId xmlns:a16="http://schemas.microsoft.com/office/drawing/2014/main" val="410127295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#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Experiments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Protocol(s) executed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Number of volunteers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Evaluation criteria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Claims</a:t>
                      </a:r>
                      <a:endParaRPr lang="en-US" sz="1100" b="1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45573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1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Throughput tes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GS, Fastes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1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MR Value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Fastest &gt; GS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303475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2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Image quality tes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GS, Fastest, EE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5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MS-SSIM, PSNR, median brain-masked local SNR, var-Lap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Fastest ~= EE/GS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4075806068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3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SNR recovery test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-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-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RMSE</a:t>
                      </a:r>
                      <a:r>
                        <a:rPr kumimoji="0" lang="en-US" sz="1100" b="0" u="none" strike="noStrike" kern="1200" cap="none" spc="0" normalizeH="0" baseline="-2500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vol</a:t>
                      </a:r>
                      <a:r>
                        <a:rPr kumimoji="0" lang="en-US" sz="11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, </a:t>
                      </a: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MS-</a:t>
                      </a:r>
                      <a:r>
                        <a:rPr kumimoji="0" lang="en-US" sz="11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SSIM, PSNR</a:t>
                      </a:r>
                      <a:endParaRPr kumimoji="0" 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Baseline-denoised Fastest ~= GS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845138575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4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Repeatability tes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GS, Fastes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5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kumimoji="0" lang="en-US" sz="1100" b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RMSE</a:t>
                      </a:r>
                      <a:r>
                        <a:rPr kumimoji="0" lang="en-US" sz="1100" b="0" u="none" strike="noStrike" kern="1200" cap="none" spc="0" normalizeH="0" baseline="-2500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vol</a:t>
                      </a: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, MS-SSIM, PSNR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CV, ICC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904327317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5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Interpolation test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-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-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kumimoji="0" lang="en-US" sz="1100" b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RMSE</a:t>
                      </a:r>
                      <a:r>
                        <a:rPr kumimoji="0" lang="en-US" sz="1100" b="0" u="none" strike="noStrike" kern="1200" cap="none" spc="0" normalizeH="0" baseline="-2500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vol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178932748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4FDE2B4-4B14-5DF0-D755-453892176CF0}"/>
              </a:ext>
            </a:extLst>
          </p:cNvPr>
          <p:cNvSpPr txBox="1"/>
          <p:nvPr/>
        </p:nvSpPr>
        <p:spPr>
          <a:xfrm>
            <a:off x="0" y="6611779"/>
            <a:ext cx="121920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Table 2.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 The five experiments performed in this work and the corresponding protocols involved, number of volunteers imaged, claims/hypotheses investigated and the quantitative evaluation criteria.</a:t>
            </a:r>
          </a:p>
        </p:txBody>
      </p:sp>
    </p:spTree>
    <p:extLst>
      <p:ext uri="{BB962C8B-B14F-4D97-AF65-F5344CB8AC3E}">
        <p14:creationId xmlns:p14="http://schemas.microsoft.com/office/powerpoint/2010/main" val="1111261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5</TotalTime>
  <Words>469</Words>
  <Application>Microsoft Office PowerPoint</Application>
  <PresentationFormat>Widescreen</PresentationFormat>
  <Paragraphs>79</Paragraphs>
  <Slides>6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Cambria Math</vt:lpstr>
      <vt:lpstr>Roboto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erthi Sravan Ravi</dc:creator>
  <cp:lastModifiedBy>Keerthi Sravan Ravi</cp:lastModifiedBy>
  <cp:revision>86</cp:revision>
  <dcterms:created xsi:type="dcterms:W3CDTF">2022-08-29T14:27:09Z</dcterms:created>
  <dcterms:modified xsi:type="dcterms:W3CDTF">2023-03-30T13:59:53Z</dcterms:modified>
</cp:coreProperties>
</file>